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  <p:sldId id="280" r:id="rId5"/>
    <p:sldId id="283" r:id="rId6"/>
    <p:sldId id="284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1A0E0"/>
    <a:srgbClr val="A472D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2.xml"/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-33655" y="6457315"/>
            <a:ext cx="6096000" cy="414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Figure S1 </a:t>
            </a:r>
            <a:r>
              <a:rPr lang="en-US" sz="14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| 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low chart of the study participants selection process.</a:t>
            </a:r>
            <a:endParaRPr lang="en-US" altLang="zh-CN" sz="14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grpSp>
        <p:nvGrpSpPr>
          <p:cNvPr id="36" name="组合 35"/>
          <p:cNvGrpSpPr/>
          <p:nvPr/>
        </p:nvGrpSpPr>
        <p:grpSpPr>
          <a:xfrm>
            <a:off x="2141855" y="262255"/>
            <a:ext cx="8975090" cy="4605655"/>
            <a:chOff x="3373" y="237"/>
            <a:chExt cx="14134" cy="7253"/>
          </a:xfrm>
        </p:grpSpPr>
        <p:sp>
          <p:nvSpPr>
            <p:cNvPr id="13" name="文本框 12"/>
            <p:cNvSpPr txBox="1"/>
            <p:nvPr/>
          </p:nvSpPr>
          <p:spPr>
            <a:xfrm>
              <a:off x="5417" y="3297"/>
              <a:ext cx="8293" cy="75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lnSpc>
                  <a:spcPct val="170000"/>
                </a:lnSpc>
              </a:pP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Data included in final statistical analysis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(</a:t>
              </a:r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= 11285) 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3373" y="335"/>
              <a:ext cx="12349" cy="84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Chinese school-aged students were recruited from Shandong Province in 2023-2024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 (</a:t>
              </a:r>
              <a:r>
                <a:rPr lang="en-US" altLang="zh-CN" sz="1200" b="1" i="1" dirty="0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 = 11359)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>
              <a:off x="3373" y="237"/>
              <a:ext cx="12348" cy="8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>
                <a:lnSpc>
                  <a:spcPct val="150000"/>
                </a:lnSpc>
              </a:pPr>
              <a:endParaRPr lang="zh-CN" altLang="en-US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0907" y="1627"/>
              <a:ext cx="6599" cy="110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lnSpc>
                  <a:spcPct val="140000"/>
                </a:lnSpc>
              </a:pP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74  students were excluded due to 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>
                <a:lnSpc>
                  <a:spcPct val="140000"/>
                </a:lnSpc>
              </a:pP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uncompleted questionnaire (</a:t>
              </a:r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 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= 2) and 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BMI</a:t>
              </a:r>
              <a:r>
                <a:rPr lang="zh-CN" altLang="en-US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＞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40 (</a:t>
              </a:r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n 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= 72)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>
                <a:lnSpc>
                  <a:spcPct val="150000"/>
                </a:lnSpc>
              </a:pP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>
              <a:off x="10941" y="1610"/>
              <a:ext cx="6566" cy="11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>
                <a:lnSpc>
                  <a:spcPct val="150000"/>
                </a:lnSpc>
              </a:pPr>
              <a:endParaRPr lang="zh-CN" altLang="en-US"/>
            </a:p>
          </p:txBody>
        </p:sp>
        <p:sp>
          <p:nvSpPr>
            <p:cNvPr id="12" name="矩形 11"/>
            <p:cNvSpPr/>
            <p:nvPr/>
          </p:nvSpPr>
          <p:spPr>
            <a:xfrm>
              <a:off x="3373" y="3252"/>
              <a:ext cx="12349" cy="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34" name="直接箭头连接符 33"/>
            <p:cNvCxnSpPr/>
            <p:nvPr/>
          </p:nvCxnSpPr>
          <p:spPr>
            <a:xfrm>
              <a:off x="9557" y="2184"/>
              <a:ext cx="135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>
              <a:stCxn id="4" idx="2"/>
            </p:cNvCxnSpPr>
            <p:nvPr/>
          </p:nvCxnSpPr>
          <p:spPr>
            <a:xfrm>
              <a:off x="9547" y="1080"/>
              <a:ext cx="1" cy="209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grpSp>
          <p:nvGrpSpPr>
            <p:cNvPr id="26" name="组合 25"/>
            <p:cNvGrpSpPr/>
            <p:nvPr/>
          </p:nvGrpSpPr>
          <p:grpSpPr>
            <a:xfrm rot="0">
              <a:off x="5598" y="5019"/>
              <a:ext cx="3643" cy="800"/>
              <a:chOff x="5355" y="7299"/>
              <a:chExt cx="3643" cy="800"/>
            </a:xfrm>
          </p:grpSpPr>
          <p:sp>
            <p:nvSpPr>
              <p:cNvPr id="21" name="矩形 20"/>
              <p:cNvSpPr/>
              <p:nvPr/>
            </p:nvSpPr>
            <p:spPr>
              <a:xfrm>
                <a:off x="5355" y="7299"/>
                <a:ext cx="3643" cy="8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5984" y="7345"/>
                <a:ext cx="2463" cy="752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>
                  <a:lnSpc>
                    <a:spcPct val="170000"/>
                  </a:lnSpc>
                </a:pPr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Obesity (</a:t>
                </a:r>
                <a:r>
                  <a:rPr lang="en-US" altLang="zh-CN" sz="1200" b="1" i="1">
                    <a:latin typeface="Times New Roman" panose="02020603050405020304" charset="0"/>
                    <a:cs typeface="Times New Roman" panose="02020603050405020304" charset="0"/>
                  </a:rPr>
                  <a:t>n</a:t>
                </a:r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 = 1681) </a:t>
                </a:r>
                <a:endParaRPr lang="en-US" altLang="zh-CN" sz="12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grpSp>
          <p:nvGrpSpPr>
            <p:cNvPr id="25" name="组合 24"/>
            <p:cNvGrpSpPr/>
            <p:nvPr/>
          </p:nvGrpSpPr>
          <p:grpSpPr>
            <a:xfrm rot="0">
              <a:off x="9887" y="5019"/>
              <a:ext cx="3642" cy="800"/>
              <a:chOff x="9584" y="7299"/>
              <a:chExt cx="3642" cy="800"/>
            </a:xfrm>
          </p:grpSpPr>
          <p:sp>
            <p:nvSpPr>
              <p:cNvPr id="23" name="矩形 22"/>
              <p:cNvSpPr/>
              <p:nvPr/>
            </p:nvSpPr>
            <p:spPr>
              <a:xfrm>
                <a:off x="9584" y="7299"/>
                <a:ext cx="3643" cy="8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4" name="文本框 23"/>
              <p:cNvSpPr txBox="1"/>
              <p:nvPr/>
            </p:nvSpPr>
            <p:spPr>
              <a:xfrm>
                <a:off x="10174" y="7345"/>
                <a:ext cx="2463" cy="752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ctr">
                  <a:lnSpc>
                    <a:spcPct val="170000"/>
                  </a:lnSpc>
                </a:pPr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Control (</a:t>
                </a:r>
                <a:r>
                  <a:rPr lang="en-US" altLang="zh-CN" sz="1200" b="1" i="1">
                    <a:latin typeface="Times New Roman" panose="02020603050405020304" charset="0"/>
                    <a:cs typeface="Times New Roman" panose="02020603050405020304" charset="0"/>
                  </a:rPr>
                  <a:t>n</a:t>
                </a:r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 = 9604) </a:t>
                </a:r>
                <a:endParaRPr lang="en-US" altLang="zh-CN" sz="12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cxnSp>
          <p:nvCxnSpPr>
            <p:cNvPr id="27" name="肘形连接符 26"/>
            <p:cNvCxnSpPr>
              <a:stCxn id="12" idx="2"/>
              <a:endCxn id="22" idx="0"/>
            </p:cNvCxnSpPr>
            <p:nvPr/>
          </p:nvCxnSpPr>
          <p:spPr>
            <a:xfrm rot="5400000">
              <a:off x="7997" y="3514"/>
              <a:ext cx="1013" cy="2089"/>
            </a:xfrm>
            <a:prstGeom prst="bentConnector3">
              <a:avLst>
                <a:gd name="adj1" fmla="val 50049"/>
              </a:avLst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28" name="肘形连接符 27"/>
            <p:cNvCxnSpPr>
              <a:stCxn id="12" idx="2"/>
              <a:endCxn id="24" idx="0"/>
            </p:cNvCxnSpPr>
            <p:nvPr/>
          </p:nvCxnSpPr>
          <p:spPr>
            <a:xfrm rot="5400000" flipV="1">
              <a:off x="10122" y="3478"/>
              <a:ext cx="1013" cy="2161"/>
            </a:xfrm>
            <a:prstGeom prst="bentConnector3">
              <a:avLst>
                <a:gd name="adj1" fmla="val 50049"/>
              </a:avLst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7" name="肘形连接符 16"/>
            <p:cNvCxnSpPr/>
            <p:nvPr/>
          </p:nvCxnSpPr>
          <p:spPr>
            <a:xfrm rot="5400000" flipV="1">
              <a:off x="8061" y="5215"/>
              <a:ext cx="885" cy="2089"/>
            </a:xfrm>
            <a:prstGeom prst="bentConnector3">
              <a:avLst>
                <a:gd name="adj1" fmla="val 50056"/>
              </a:avLst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8" name="肘形连接符 17"/>
            <p:cNvCxnSpPr/>
            <p:nvPr/>
          </p:nvCxnSpPr>
          <p:spPr>
            <a:xfrm rot="5400000">
              <a:off x="10186" y="5179"/>
              <a:ext cx="885" cy="2161"/>
            </a:xfrm>
            <a:prstGeom prst="bentConnector3">
              <a:avLst>
                <a:gd name="adj1" fmla="val 50056"/>
              </a:avLst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29" name="文本框 28"/>
            <p:cNvSpPr txBox="1"/>
            <p:nvPr/>
          </p:nvSpPr>
          <p:spPr>
            <a:xfrm>
              <a:off x="7778" y="6694"/>
              <a:ext cx="3618" cy="79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lnSpc>
                  <a:spcPct val="170000"/>
                </a:lnSpc>
              </a:pP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Physical exercise survey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>
              <a:off x="7778" y="6738"/>
              <a:ext cx="3609" cy="65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3707" y="6694"/>
              <a:ext cx="3610" cy="79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lnSpc>
                  <a:spcPct val="170000"/>
                </a:lnSpc>
              </a:pP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Dietary survey 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>
              <a:off x="3708" y="6738"/>
              <a:ext cx="3609" cy="65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1710" y="6694"/>
              <a:ext cx="3643" cy="79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lnSpc>
                  <a:spcPct val="170000"/>
                </a:lnSpc>
              </a:pP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</a:rPr>
                <a:t>Nutritional literacy investigation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" name="矩形 34"/>
            <p:cNvSpPr/>
            <p:nvPr/>
          </p:nvSpPr>
          <p:spPr>
            <a:xfrm>
              <a:off x="11709" y="6738"/>
              <a:ext cx="3783" cy="65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1640205" y="5029835"/>
            <a:ext cx="8911590" cy="1483360"/>
            <a:chOff x="2681" y="7921"/>
            <a:chExt cx="14034" cy="2336"/>
          </a:xfrm>
        </p:grpSpPr>
        <p:sp>
          <p:nvSpPr>
            <p:cNvPr id="10" name="文本框 9"/>
            <p:cNvSpPr txBox="1"/>
            <p:nvPr/>
          </p:nvSpPr>
          <p:spPr>
            <a:xfrm>
              <a:off x="2746" y="7921"/>
              <a:ext cx="13771" cy="2292"/>
            </a:xfrm>
            <a:prstGeom prst="rect">
              <a:avLst/>
            </a:prstGeom>
          </p:spPr>
          <p:txBody>
            <a:bodyPr wrap="square">
              <a:noAutofit/>
            </a:bodyPr>
            <a:p>
              <a:pPr marL="0" indent="0" algn="l" defTabSz="266700">
                <a:lnSpc>
                  <a:spcPct val="11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b="1" i="0" u="sng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Inclusion criteria</a:t>
              </a:r>
              <a:endParaRPr lang="en-US" altLang="zh-CN" sz="1200" b="1" i="0" u="sng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marL="76200" indent="0" algn="l" defTabSz="266700">
                <a:lnSpc>
                  <a:spcPct val="11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i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1.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Students a</a:t>
              </a:r>
              <a:r>
                <a:rPr lang="en-US" altLang="zh-CN" sz="1200" i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ged between 6 and 18 years ;</a:t>
              </a:r>
              <a:endParaRPr lang="en-US" altLang="zh-CN" sz="1200" i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endParaRPr>
            </a:p>
            <a:p>
              <a:pPr marL="76200" indent="0" algn="l" defTabSz="266700">
                <a:lnSpc>
                  <a:spcPct val="11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i="0">
                  <a:solidFill>
                    <a:srgbClr val="000000"/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rPr>
                <a:t>2.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Students who agreed to participate in the questionnaire survey ;</a:t>
              </a:r>
              <a:endParaRPr lang="en-US" altLang="zh-CN" sz="120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marL="76200" indent="0" algn="l" defTabSz="266700">
                <a:lnSpc>
                  <a:spcPct val="11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3.</a:t>
              </a:r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Students who were able to complete the questionnaire independently or with minimal assistance.</a:t>
              </a:r>
              <a:endParaRPr lang="en-US" altLang="zh-CN" sz="1200" i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endParaRPr>
            </a:p>
            <a:p>
              <a:pPr marL="76200" indent="0" algn="l" defTabSz="266700">
                <a:lnSpc>
                  <a:spcPct val="11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b="1" i="0" u="sng">
                  <a:solidFill>
                    <a:srgbClr val="000000"/>
                  </a:solidFill>
                  <a:latin typeface="Times New Roman" panose="02020603050405020304"/>
                  <a:ea typeface="Times New Roman" panose="02020603050405020304"/>
                </a:rPr>
                <a:t>E</a:t>
              </a:r>
              <a:r>
                <a:rPr lang="en-US" altLang="zh-CN" sz="1200" b="1" i="0" u="sng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</a:rPr>
                <a:t>xclusion criteria</a:t>
              </a:r>
              <a:endParaRPr lang="en-US" altLang="zh-CN" sz="1200" b="1" i="0" u="sng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endParaRPr>
            </a:p>
            <a:p>
              <a:pPr marL="76200" indent="0" algn="l" defTabSz="266700">
                <a:lnSpc>
                  <a:spcPct val="11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i="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</a:rPr>
                <a:t>1.Students who were absent during the survey period or failed to complete the questionnaire due to illness or personal reasons ;</a:t>
              </a:r>
              <a:endParaRPr lang="en-US" altLang="zh-CN" sz="1200" i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endParaRPr>
            </a:p>
            <a:p>
              <a:pPr marL="76200" indent="0" algn="l" defTabSz="266700">
                <a:lnSpc>
                  <a:spcPct val="11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200" i="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</a:rPr>
                <a:t>2.Students who submitted questionnaires with incomplete information on key variables of physical activity and dietary intake.</a:t>
              </a:r>
              <a:endParaRPr lang="en-US" altLang="zh-CN" sz="1200" i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2681" y="7941"/>
              <a:ext cx="14034" cy="231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组合 48"/>
          <p:cNvGrpSpPr/>
          <p:nvPr/>
        </p:nvGrpSpPr>
        <p:grpSpPr>
          <a:xfrm>
            <a:off x="1662113" y="785813"/>
            <a:ext cx="9058275" cy="4867275"/>
            <a:chOff x="2468" y="1584"/>
            <a:chExt cx="14265" cy="7665"/>
          </a:xfrm>
        </p:grpSpPr>
        <p:grpSp>
          <p:nvGrpSpPr>
            <p:cNvPr id="24" name="组合 23"/>
            <p:cNvGrpSpPr/>
            <p:nvPr/>
          </p:nvGrpSpPr>
          <p:grpSpPr>
            <a:xfrm>
              <a:off x="6127" y="1584"/>
              <a:ext cx="3300" cy="3253"/>
              <a:chOff x="4262" y="4643"/>
              <a:chExt cx="3300" cy="3253"/>
            </a:xfrm>
          </p:grpSpPr>
          <p:pic>
            <p:nvPicPr>
              <p:cNvPr id="21" name="图片 20" descr="小学患病率"/>
              <p:cNvPicPr>
                <a:picLocks noChangeAspect="1"/>
              </p:cNvPicPr>
              <p:nvPr/>
            </p:nvPicPr>
            <p:blipFill>
              <a:blip r:embed="rId1"/>
              <a:srcRect r="31000" b="18324"/>
              <a:stretch>
                <a:fillRect/>
              </a:stretch>
            </p:blipFill>
            <p:spPr>
              <a:xfrm>
                <a:off x="4262" y="4643"/>
                <a:ext cx="3300" cy="3253"/>
              </a:xfrm>
              <a:prstGeom prst="rect">
                <a:avLst/>
              </a:prstGeom>
            </p:spPr>
          </p:pic>
          <p:sp>
            <p:nvSpPr>
              <p:cNvPr id="22" name="文本框 21"/>
              <p:cNvSpPr txBox="1"/>
              <p:nvPr/>
            </p:nvSpPr>
            <p:spPr>
              <a:xfrm>
                <a:off x="5256" y="6068"/>
                <a:ext cx="116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Primary</a:t>
                </a:r>
                <a:endParaRPr lang="en-US" altLang="zh-CN" sz="12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>
                <a:off x="6037" y="5287"/>
                <a:ext cx="874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>
                    <a:latin typeface="Times New Roman" panose="02020603050405020304" charset="0"/>
                    <a:cs typeface="Times New Roman" panose="02020603050405020304" charset="0"/>
                  </a:rPr>
                  <a:t>20.4%</a:t>
                </a:r>
                <a:endParaRPr lang="zh-CN" altLang="en-US" sz="10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grpSp>
          <p:nvGrpSpPr>
            <p:cNvPr id="35" name="组合 34"/>
            <p:cNvGrpSpPr/>
            <p:nvPr/>
          </p:nvGrpSpPr>
          <p:grpSpPr>
            <a:xfrm>
              <a:off x="9738" y="1617"/>
              <a:ext cx="3300" cy="3252"/>
              <a:chOff x="9974" y="2012"/>
              <a:chExt cx="3300" cy="3252"/>
            </a:xfrm>
          </p:grpSpPr>
          <p:grpSp>
            <p:nvGrpSpPr>
              <p:cNvPr id="27" name="组合 26"/>
              <p:cNvGrpSpPr/>
              <p:nvPr/>
            </p:nvGrpSpPr>
            <p:grpSpPr>
              <a:xfrm>
                <a:off x="9974" y="2012"/>
                <a:ext cx="3300" cy="3252"/>
                <a:chOff x="7950" y="4643"/>
                <a:chExt cx="3300" cy="3252"/>
              </a:xfrm>
            </p:grpSpPr>
            <p:pic>
              <p:nvPicPr>
                <p:cNvPr id="25" name="图片 24" descr="初中患病率"/>
                <p:cNvPicPr>
                  <a:picLocks noChangeAspect="1"/>
                </p:cNvPicPr>
                <p:nvPr/>
              </p:nvPicPr>
              <p:blipFill>
                <a:blip r:embed="rId2"/>
                <a:srcRect r="31663" b="19145"/>
                <a:stretch>
                  <a:fillRect/>
                </a:stretch>
              </p:blipFill>
              <p:spPr>
                <a:xfrm>
                  <a:off x="7950" y="4643"/>
                  <a:ext cx="3300" cy="3252"/>
                </a:xfrm>
                <a:prstGeom prst="rect">
                  <a:avLst/>
                </a:prstGeom>
              </p:spPr>
            </p:pic>
            <p:sp>
              <p:nvSpPr>
                <p:cNvPr id="26" name="文本框 25"/>
                <p:cNvSpPr txBox="1"/>
                <p:nvPr/>
              </p:nvSpPr>
              <p:spPr>
                <a:xfrm>
                  <a:off x="9452" y="5078"/>
                  <a:ext cx="874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b="1">
                      <a:latin typeface="Times New Roman" panose="02020603050405020304" charset="0"/>
                      <a:cs typeface="Times New Roman" panose="02020603050405020304" charset="0"/>
                    </a:rPr>
                    <a:t>10.1%</a:t>
                  </a:r>
                  <a:endParaRPr lang="zh-CN" altLang="en-US" sz="1000" b="1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</p:grpSp>
          <p:sp>
            <p:nvSpPr>
              <p:cNvPr id="28" name="文本框 27"/>
              <p:cNvSpPr txBox="1"/>
              <p:nvPr/>
            </p:nvSpPr>
            <p:spPr>
              <a:xfrm>
                <a:off x="10963" y="3420"/>
                <a:ext cx="116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Junior</a:t>
                </a:r>
                <a:endParaRPr lang="en-US" altLang="zh-CN" sz="12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grpSp>
          <p:nvGrpSpPr>
            <p:cNvPr id="11" name="组合 10"/>
            <p:cNvGrpSpPr/>
            <p:nvPr/>
          </p:nvGrpSpPr>
          <p:grpSpPr>
            <a:xfrm>
              <a:off x="2468" y="5512"/>
              <a:ext cx="3231" cy="3317"/>
              <a:chOff x="463" y="908"/>
              <a:chExt cx="3231" cy="3317"/>
            </a:xfrm>
          </p:grpSpPr>
          <p:pic>
            <p:nvPicPr>
              <p:cNvPr id="5" name="图片 4" descr="男患病率"/>
              <p:cNvPicPr>
                <a:picLocks noChangeAspect="1"/>
              </p:cNvPicPr>
              <p:nvPr/>
            </p:nvPicPr>
            <p:blipFill>
              <a:blip r:embed="rId3"/>
              <a:srcRect r="33382" b="17902"/>
              <a:stretch>
                <a:fillRect/>
              </a:stretch>
            </p:blipFill>
            <p:spPr>
              <a:xfrm>
                <a:off x="463" y="908"/>
                <a:ext cx="3231" cy="3317"/>
              </a:xfrm>
              <a:prstGeom prst="rect">
                <a:avLst/>
              </a:prstGeom>
            </p:spPr>
          </p:pic>
          <p:sp>
            <p:nvSpPr>
              <p:cNvPr id="6" name="文本框 5"/>
              <p:cNvSpPr txBox="1"/>
              <p:nvPr/>
            </p:nvSpPr>
            <p:spPr>
              <a:xfrm>
                <a:off x="2188" y="1495"/>
                <a:ext cx="874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>
                    <a:latin typeface="Times New Roman" panose="02020603050405020304" charset="0"/>
                    <a:cs typeface="Times New Roman" panose="02020603050405020304" charset="0"/>
                  </a:rPr>
                  <a:t>18.7%</a:t>
                </a:r>
                <a:endParaRPr lang="zh-CN" altLang="en-US" sz="10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1567" y="2326"/>
                <a:ext cx="101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Boys</a:t>
                </a:r>
                <a:endParaRPr lang="en-US" altLang="zh-CN" sz="12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grpSp>
          <p:nvGrpSpPr>
            <p:cNvPr id="10" name="组合 9"/>
            <p:cNvGrpSpPr/>
            <p:nvPr/>
          </p:nvGrpSpPr>
          <p:grpSpPr>
            <a:xfrm>
              <a:off x="6135" y="5576"/>
              <a:ext cx="3243" cy="3192"/>
              <a:chOff x="3905" y="908"/>
              <a:chExt cx="3243" cy="3192"/>
            </a:xfrm>
          </p:grpSpPr>
          <p:pic>
            <p:nvPicPr>
              <p:cNvPr id="4" name="图片 3" descr="女患病率"/>
              <p:cNvPicPr>
                <a:picLocks noChangeAspect="1"/>
              </p:cNvPicPr>
              <p:nvPr/>
            </p:nvPicPr>
            <p:blipFill>
              <a:blip r:embed="rId4"/>
              <a:srcRect r="33635" b="21109"/>
              <a:stretch>
                <a:fillRect/>
              </a:stretch>
            </p:blipFill>
            <p:spPr>
              <a:xfrm>
                <a:off x="3905" y="908"/>
                <a:ext cx="3243" cy="3192"/>
              </a:xfrm>
              <a:prstGeom prst="rect">
                <a:avLst/>
              </a:prstGeom>
            </p:spPr>
          </p:pic>
          <p:sp>
            <p:nvSpPr>
              <p:cNvPr id="8" name="文本框 7"/>
              <p:cNvSpPr txBox="1"/>
              <p:nvPr/>
            </p:nvSpPr>
            <p:spPr>
              <a:xfrm>
                <a:off x="5012" y="2326"/>
                <a:ext cx="101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Girls</a:t>
                </a:r>
                <a:endParaRPr lang="en-US" altLang="zh-CN" sz="12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5448" y="1354"/>
                <a:ext cx="874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>
                    <a:latin typeface="Times New Roman" panose="02020603050405020304" charset="0"/>
                    <a:cs typeface="Times New Roman" panose="02020603050405020304" charset="0"/>
                  </a:rPr>
                  <a:t>11.1%</a:t>
                </a:r>
                <a:endParaRPr lang="zh-CN" altLang="en-US" sz="10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>
              <a:off x="9765" y="5576"/>
              <a:ext cx="3288" cy="3213"/>
              <a:chOff x="7586" y="908"/>
              <a:chExt cx="3288" cy="3213"/>
            </a:xfrm>
          </p:grpSpPr>
          <p:pic>
            <p:nvPicPr>
              <p:cNvPr id="13" name="图片 12" descr="城市患病率"/>
              <p:cNvPicPr>
                <a:picLocks noChangeAspect="1"/>
              </p:cNvPicPr>
              <p:nvPr/>
            </p:nvPicPr>
            <p:blipFill>
              <a:blip r:embed="rId5"/>
              <a:srcRect r="32760" b="21109"/>
              <a:stretch>
                <a:fillRect/>
              </a:stretch>
            </p:blipFill>
            <p:spPr>
              <a:xfrm>
                <a:off x="7586" y="908"/>
                <a:ext cx="3288" cy="3213"/>
              </a:xfrm>
              <a:prstGeom prst="rect">
                <a:avLst/>
              </a:prstGeom>
            </p:spPr>
          </p:pic>
          <p:sp>
            <p:nvSpPr>
              <p:cNvPr id="14" name="文本框 13"/>
              <p:cNvSpPr txBox="1"/>
              <p:nvPr/>
            </p:nvSpPr>
            <p:spPr>
              <a:xfrm>
                <a:off x="9236" y="1466"/>
                <a:ext cx="1028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>
                    <a:latin typeface="Times New Roman" panose="02020603050405020304" charset="0"/>
                    <a:cs typeface="Times New Roman" panose="02020603050405020304" charset="0"/>
                  </a:rPr>
                  <a:t>15.8%</a:t>
                </a:r>
                <a:endParaRPr lang="zh-CN" altLang="en-US" sz="10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8704" y="2326"/>
                <a:ext cx="101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Urban</a:t>
                </a:r>
                <a:endParaRPr lang="en-US" altLang="zh-CN" sz="12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grpSp>
          <p:nvGrpSpPr>
            <p:cNvPr id="18" name="组合 17"/>
            <p:cNvGrpSpPr/>
            <p:nvPr/>
          </p:nvGrpSpPr>
          <p:grpSpPr>
            <a:xfrm>
              <a:off x="13401" y="5593"/>
              <a:ext cx="3332" cy="3302"/>
              <a:chOff x="11290" y="908"/>
              <a:chExt cx="3332" cy="3302"/>
            </a:xfrm>
          </p:grpSpPr>
          <p:pic>
            <p:nvPicPr>
              <p:cNvPr id="12" name="图片 11" descr="农村患病率"/>
              <p:cNvPicPr>
                <a:picLocks noChangeAspect="1"/>
              </p:cNvPicPr>
              <p:nvPr/>
            </p:nvPicPr>
            <p:blipFill>
              <a:blip r:embed="rId6"/>
              <a:srcRect r="31000" b="17902"/>
              <a:stretch>
                <a:fillRect/>
              </a:stretch>
            </p:blipFill>
            <p:spPr>
              <a:xfrm>
                <a:off x="11290" y="908"/>
                <a:ext cx="3332" cy="3302"/>
              </a:xfrm>
              <a:prstGeom prst="rect">
                <a:avLst/>
              </a:prstGeom>
            </p:spPr>
          </p:pic>
          <p:sp>
            <p:nvSpPr>
              <p:cNvPr id="16" name="文本框 15"/>
              <p:cNvSpPr txBox="1"/>
              <p:nvPr/>
            </p:nvSpPr>
            <p:spPr>
              <a:xfrm>
                <a:off x="12401" y="2310"/>
                <a:ext cx="101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Rural</a:t>
                </a:r>
                <a:endParaRPr lang="en-US" altLang="zh-CN" sz="12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12886" y="1418"/>
                <a:ext cx="928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>
                    <a:latin typeface="Times New Roman" panose="02020603050405020304" charset="0"/>
                    <a:cs typeface="Times New Roman" panose="02020603050405020304" charset="0"/>
                  </a:rPr>
                  <a:t>13.9%</a:t>
                </a:r>
                <a:endParaRPr lang="zh-CN" altLang="en-US" sz="10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grpSp>
          <p:nvGrpSpPr>
            <p:cNvPr id="3" name="组合 2"/>
            <p:cNvGrpSpPr/>
            <p:nvPr/>
          </p:nvGrpSpPr>
          <p:grpSpPr>
            <a:xfrm>
              <a:off x="13399" y="1617"/>
              <a:ext cx="3231" cy="3316"/>
              <a:chOff x="13726" y="1995"/>
              <a:chExt cx="3231" cy="3316"/>
            </a:xfrm>
          </p:grpSpPr>
          <p:pic>
            <p:nvPicPr>
              <p:cNvPr id="29" name="图片 28" descr="高中患病率"/>
              <p:cNvPicPr>
                <a:picLocks noChangeAspect="1"/>
              </p:cNvPicPr>
              <p:nvPr/>
            </p:nvPicPr>
            <p:blipFill>
              <a:blip r:embed="rId7"/>
              <a:srcRect r="34065" b="18772"/>
              <a:stretch>
                <a:fillRect/>
              </a:stretch>
            </p:blipFill>
            <p:spPr>
              <a:xfrm>
                <a:off x="13726" y="1995"/>
                <a:ext cx="3231" cy="3316"/>
              </a:xfrm>
              <a:prstGeom prst="rect">
                <a:avLst/>
              </a:prstGeom>
            </p:spPr>
          </p:pic>
          <p:sp>
            <p:nvSpPr>
              <p:cNvPr id="30" name="文本框 29"/>
              <p:cNvSpPr txBox="1"/>
              <p:nvPr/>
            </p:nvSpPr>
            <p:spPr>
              <a:xfrm>
                <a:off x="14740" y="3420"/>
                <a:ext cx="1162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latin typeface="Times New Roman" panose="02020603050405020304" charset="0"/>
                    <a:cs typeface="Times New Roman" panose="02020603050405020304" charset="0"/>
                  </a:rPr>
                  <a:t>Senior</a:t>
                </a:r>
                <a:endParaRPr lang="en-US" altLang="zh-CN" sz="12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15268" y="2431"/>
                <a:ext cx="764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>
                    <a:latin typeface="Times New Roman" panose="02020603050405020304" charset="0"/>
                    <a:cs typeface="Times New Roman" panose="02020603050405020304" charset="0"/>
                  </a:rPr>
                  <a:t>8.8%</a:t>
                </a:r>
                <a:endParaRPr lang="en-US" altLang="zh-CN" sz="1000" b="1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pic>
          <p:nvPicPr>
            <p:cNvPr id="37" name="图片 36" descr="总患病率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501" y="1617"/>
              <a:ext cx="3186" cy="3186"/>
            </a:xfrm>
            <a:prstGeom prst="rect">
              <a:avLst/>
            </a:prstGeom>
          </p:spPr>
        </p:pic>
        <p:sp>
          <p:nvSpPr>
            <p:cNvPr id="38" name="文本框 37"/>
            <p:cNvSpPr txBox="1"/>
            <p:nvPr/>
          </p:nvSpPr>
          <p:spPr>
            <a:xfrm>
              <a:off x="4163" y="2091"/>
              <a:ext cx="874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Times New Roman" panose="02020603050405020304" charset="0"/>
                  <a:cs typeface="Times New Roman" panose="02020603050405020304" charset="0"/>
                </a:rPr>
                <a:t>14.9%</a:t>
              </a:r>
              <a:endParaRPr lang="zh-CN" altLang="en-US" sz="10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3539" y="3027"/>
              <a:ext cx="1162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Total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2756" y="4869"/>
              <a:ext cx="272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= 1681 (11285)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6390" y="4869"/>
              <a:ext cx="272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= 1141 (5582)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0012" y="4869"/>
              <a:ext cx="272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= 303 (3303)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3646" y="4869"/>
              <a:ext cx="272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= 237 (2700)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2756" y="8815"/>
              <a:ext cx="272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= 1052 (5634)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6390" y="8815"/>
              <a:ext cx="272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= 629 (5651)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10012" y="8815"/>
              <a:ext cx="272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= 932 (5897)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13646" y="8815"/>
              <a:ext cx="272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i="1">
                  <a:latin typeface="Times New Roman" panose="02020603050405020304" charset="0"/>
                  <a:cs typeface="Times New Roman" panose="02020603050405020304" charset="0"/>
                </a:rPr>
                <a:t>N</a:t>
              </a:r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 = 749 (5388)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635" y="6111240"/>
            <a:ext cx="12191365" cy="7467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Figure S2 |</a:t>
            </a:r>
            <a:r>
              <a:rPr lang="en-US" altLang="zh-CN" sz="14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400" b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revalence of obesity among school-age students according to gender, grade, and residential areas.</a:t>
            </a:r>
            <a:r>
              <a:rPr lang="en-US" altLang="zh-CN" sz="14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Data were expressed as number of participants with obesity (Total number of participants).</a:t>
            </a:r>
            <a:endParaRPr lang="en-US" altLang="zh-CN" sz="14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图片 38"/>
          <p:cNvPicPr>
            <a:picLocks noChangeAspect="1"/>
          </p:cNvPicPr>
          <p:nvPr/>
        </p:nvPicPr>
        <p:blipFill>
          <a:blip r:embed="rId1"/>
          <a:srcRect l="19471" t="9839" b="8938"/>
          <a:stretch>
            <a:fillRect/>
          </a:stretch>
        </p:blipFill>
        <p:spPr>
          <a:xfrm>
            <a:off x="1102360" y="2360295"/>
            <a:ext cx="2664460" cy="2647950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2"/>
          <a:srcRect l="19030" t="10486" b="8879"/>
          <a:stretch>
            <a:fillRect/>
          </a:stretch>
        </p:blipFill>
        <p:spPr>
          <a:xfrm>
            <a:off x="3756025" y="2379345"/>
            <a:ext cx="2640965" cy="2628900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3"/>
          <a:srcRect l="19030" t="10153" b="9212"/>
          <a:stretch>
            <a:fillRect/>
          </a:stretch>
        </p:blipFill>
        <p:spPr>
          <a:xfrm>
            <a:off x="6414770" y="2378710"/>
            <a:ext cx="2654935" cy="2629535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>
          <a:blip r:embed="rId4"/>
          <a:srcRect l="19383" t="10898" b="8926"/>
          <a:stretch>
            <a:fillRect/>
          </a:stretch>
        </p:blipFill>
        <p:spPr>
          <a:xfrm>
            <a:off x="9077960" y="2379345"/>
            <a:ext cx="2629535" cy="2620645"/>
          </a:xfrm>
          <a:prstGeom prst="rect">
            <a:avLst/>
          </a:prstGeom>
        </p:spPr>
      </p:pic>
      <p:sp>
        <p:nvSpPr>
          <p:cNvPr id="43" name="文本框 42"/>
          <p:cNvSpPr txBox="1"/>
          <p:nvPr/>
        </p:nvSpPr>
        <p:spPr>
          <a:xfrm>
            <a:off x="-104140" y="249618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-104140" y="292354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-104140" y="335089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-104140" y="377825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-104140" y="420560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-104140" y="463296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 rot="16200000">
            <a:off x="77533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 rot="16200000">
            <a:off x="119951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 rot="16200000">
            <a:off x="162369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 rot="16200000">
            <a:off x="204787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 rot="16200000">
            <a:off x="248031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 rot="16200000">
            <a:off x="288798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 rot="16200000">
            <a:off x="342201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 rot="16200000">
            <a:off x="384619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 rot="16200000">
            <a:off x="427037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 rot="16200000">
            <a:off x="469455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 rot="16200000">
            <a:off x="512699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 rot="16200000">
            <a:off x="553466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 rot="16200000">
            <a:off x="609727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 rot="16200000">
            <a:off x="652145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 rot="16200000">
            <a:off x="694563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 rot="16200000">
            <a:off x="736981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 rot="16200000">
            <a:off x="780224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 rot="16200000">
            <a:off x="820991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 rot="16200000">
            <a:off x="876300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 rot="16200000">
            <a:off x="918718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 rot="16200000">
            <a:off x="961136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 rot="16200000">
            <a:off x="1003554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 rot="16200000">
            <a:off x="1046797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 rot="16200000">
            <a:off x="1087564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75" name="直接连接符 74"/>
          <p:cNvCxnSpPr/>
          <p:nvPr/>
        </p:nvCxnSpPr>
        <p:spPr>
          <a:xfrm>
            <a:off x="1132205" y="5041265"/>
            <a:ext cx="2585085" cy="0"/>
          </a:xfrm>
          <a:prstGeom prst="line">
            <a:avLst/>
          </a:prstGeom>
          <a:ln w="19050" cap="flat" cmpd="sng" algn="ctr">
            <a:solidFill>
              <a:schemeClr val="accent6">
                <a:lumMod val="75000"/>
              </a:schemeClr>
            </a:solidFill>
            <a:prstDash val="dash"/>
            <a:miter lim="800000"/>
          </a:ln>
        </p:spPr>
        <p:style>
          <a:lnRef idx="0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>
            <a:off x="3811905" y="5041265"/>
            <a:ext cx="2585085" cy="0"/>
          </a:xfrm>
          <a:prstGeom prst="line">
            <a:avLst/>
          </a:prstGeom>
          <a:ln w="19050" cap="flat" cmpd="sng" algn="ctr">
            <a:solidFill>
              <a:schemeClr val="accent6">
                <a:lumMod val="75000"/>
              </a:schemeClr>
            </a:solidFill>
            <a:prstDash val="dash"/>
            <a:miter lim="800000"/>
          </a:ln>
        </p:spPr>
        <p:style>
          <a:lnRef idx="0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/>
        </p:nvCxnSpPr>
        <p:spPr>
          <a:xfrm>
            <a:off x="6475095" y="5041265"/>
            <a:ext cx="2585085" cy="0"/>
          </a:xfrm>
          <a:prstGeom prst="line">
            <a:avLst/>
          </a:prstGeom>
          <a:ln w="19050" cap="flat" cmpd="sng" algn="ctr">
            <a:solidFill>
              <a:schemeClr val="accent6">
                <a:lumMod val="75000"/>
              </a:schemeClr>
            </a:solidFill>
            <a:prstDash val="dash"/>
            <a:miter lim="800000"/>
          </a:ln>
        </p:spPr>
        <p:style>
          <a:lnRef idx="0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9122410" y="5041265"/>
            <a:ext cx="2585085" cy="0"/>
          </a:xfrm>
          <a:prstGeom prst="line">
            <a:avLst/>
          </a:prstGeom>
          <a:ln w="19050" cap="flat" cmpd="sng" algn="ctr">
            <a:solidFill>
              <a:schemeClr val="accent6">
                <a:lumMod val="75000"/>
              </a:schemeClr>
            </a:solidFill>
            <a:prstDash val="dash"/>
            <a:miter lim="800000"/>
          </a:ln>
        </p:spPr>
        <p:style>
          <a:lnRef idx="0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9" name="文本框 78"/>
          <p:cNvSpPr txBox="1"/>
          <p:nvPr/>
        </p:nvSpPr>
        <p:spPr>
          <a:xfrm>
            <a:off x="1812290" y="509270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l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4492625" y="509270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rimary Schoo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7130415" y="509270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Junior High Schoo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9803130" y="509270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Senior High Schoo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-635" y="5956300"/>
            <a:ext cx="12192635" cy="627380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Figure S3 </a:t>
            </a:r>
            <a:r>
              <a:rPr lang="en-US" sz="1200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|</a:t>
            </a:r>
            <a:r>
              <a:rPr lang="en-US" sz="1200" b="1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Correlation of Total scores of Nutritional Literacy with BMI, Total DDS, Plant DDS, Animal DDS, PA in the school-age children. (A) All participants and groups according to the grade. (B) Groups according to the gender and residential areas. </a:t>
            </a:r>
            <a:r>
              <a:rPr lang="en-US" sz="1200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DDS: 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Dietary Diversity Score; PA: Score of Physical Activity. 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*: </a:t>
            </a:r>
            <a:r>
              <a:rPr lang="en-US" altLang="zh-CN" sz="1200" i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&lt; 0.05; **: </a:t>
            </a:r>
            <a:r>
              <a:rPr lang="en-US" altLang="zh-CN" sz="1200" i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 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&lt; 0.01; ***: </a:t>
            </a:r>
            <a:r>
              <a:rPr lang="en-US" altLang="zh-CN" sz="1200" i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&lt; 0.001.</a:t>
            </a:r>
            <a:endParaRPr lang="en-US" altLang="zh-CN" sz="12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717655" y="3237865"/>
            <a:ext cx="405765" cy="18034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88265" y="876935"/>
            <a:ext cx="5181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88265" y="876935"/>
            <a:ext cx="5181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-635" y="5956300"/>
            <a:ext cx="12192635" cy="627380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Figure S3 </a:t>
            </a:r>
            <a:r>
              <a:rPr lang="en-US" sz="1200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|</a:t>
            </a:r>
            <a:r>
              <a:rPr lang="en-US" sz="1200" b="1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Correlation of Total scores of Nutritional Literacy with BMI, Total DDS, Plant DDS, Animal DDS, PA in the school-age children. (A) All participants and groups according to the grade. (B) Groups according to gender and residential areas. </a:t>
            </a:r>
            <a:r>
              <a:rPr lang="en-US" sz="1200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DDS: 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Dietary Diversity Score; PA: Score of Physical Activity. 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*: </a:t>
            </a:r>
            <a:r>
              <a:rPr lang="en-US" altLang="zh-CN" sz="1200" i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&lt; 0.05; **: </a:t>
            </a:r>
            <a:r>
              <a:rPr lang="en-US" altLang="zh-CN" sz="1200" i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 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&lt; 0.01; ***: </a:t>
            </a:r>
            <a:r>
              <a:rPr lang="en-US" altLang="zh-CN" sz="1200" i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&lt; 0.001.</a:t>
            </a:r>
            <a:endParaRPr lang="en-US" altLang="zh-CN" sz="1200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49" name="文本框 48"/>
          <p:cNvSpPr txBox="1"/>
          <p:nvPr/>
        </p:nvSpPr>
        <p:spPr>
          <a:xfrm rot="16200000">
            <a:off x="77533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 rot="16200000">
            <a:off x="119951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 rot="16200000">
            <a:off x="162369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 rot="16200000">
            <a:off x="204787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 rot="16200000">
            <a:off x="248031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 rot="16200000">
            <a:off x="288798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 rot="16200000">
            <a:off x="342201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 rot="16200000">
            <a:off x="384619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 rot="16200000">
            <a:off x="427037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 rot="16200000">
            <a:off x="469455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 rot="16200000">
            <a:off x="512699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 rot="16200000">
            <a:off x="553466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 rot="16200000">
            <a:off x="609727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 rot="16200000">
            <a:off x="652145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 rot="16200000">
            <a:off x="694563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 rot="16200000">
            <a:off x="736981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 rot="16200000">
            <a:off x="780224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 rot="16200000">
            <a:off x="820991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 rot="16200000">
            <a:off x="876300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 rot="16200000">
            <a:off x="918718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 rot="16200000">
            <a:off x="961136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 rot="16200000">
            <a:off x="10035540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 rot="16200000">
            <a:off x="1046797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 rot="16200000">
            <a:off x="10875645" y="164274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-104140" y="249618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Nutritional literacy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-104140" y="292354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MI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-104140" y="335089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Tot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-104140" y="377825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Animal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-104140" y="4205605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lant DD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-104140" y="463296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PA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75" name="直接连接符 74"/>
          <p:cNvCxnSpPr/>
          <p:nvPr/>
        </p:nvCxnSpPr>
        <p:spPr>
          <a:xfrm>
            <a:off x="1132205" y="5041265"/>
            <a:ext cx="2585085" cy="0"/>
          </a:xfrm>
          <a:prstGeom prst="line">
            <a:avLst/>
          </a:prstGeom>
          <a:ln w="19050" cap="flat" cmpd="sng" algn="ctr">
            <a:solidFill>
              <a:schemeClr val="accent6">
                <a:lumMod val="75000"/>
              </a:schemeClr>
            </a:solidFill>
            <a:prstDash val="dash"/>
            <a:miter lim="800000"/>
          </a:ln>
        </p:spPr>
        <p:style>
          <a:lnRef idx="0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>
            <a:off x="3811905" y="5041265"/>
            <a:ext cx="2585085" cy="0"/>
          </a:xfrm>
          <a:prstGeom prst="line">
            <a:avLst/>
          </a:prstGeom>
          <a:ln w="19050" cap="flat" cmpd="sng" algn="ctr">
            <a:solidFill>
              <a:schemeClr val="accent6">
                <a:lumMod val="75000"/>
              </a:schemeClr>
            </a:solidFill>
            <a:prstDash val="dash"/>
            <a:miter lim="800000"/>
          </a:ln>
        </p:spPr>
        <p:style>
          <a:lnRef idx="0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/>
        </p:nvCxnSpPr>
        <p:spPr>
          <a:xfrm>
            <a:off x="6475095" y="5041265"/>
            <a:ext cx="2585085" cy="0"/>
          </a:xfrm>
          <a:prstGeom prst="line">
            <a:avLst/>
          </a:prstGeom>
          <a:ln w="19050" cap="flat" cmpd="sng" algn="ctr">
            <a:solidFill>
              <a:schemeClr val="accent6">
                <a:lumMod val="75000"/>
              </a:schemeClr>
            </a:solidFill>
            <a:prstDash val="dash"/>
            <a:miter lim="800000"/>
          </a:ln>
        </p:spPr>
        <p:style>
          <a:lnRef idx="0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9122410" y="5041265"/>
            <a:ext cx="2585085" cy="0"/>
          </a:xfrm>
          <a:prstGeom prst="line">
            <a:avLst/>
          </a:prstGeom>
          <a:ln w="19050" cap="flat" cmpd="sng" algn="ctr">
            <a:solidFill>
              <a:schemeClr val="accent6">
                <a:lumMod val="75000"/>
              </a:schemeClr>
            </a:solidFill>
            <a:prstDash val="dash"/>
            <a:miter lim="800000"/>
          </a:ln>
        </p:spPr>
        <p:style>
          <a:lnRef idx="0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9" name="文本框 78"/>
          <p:cNvSpPr txBox="1"/>
          <p:nvPr/>
        </p:nvSpPr>
        <p:spPr>
          <a:xfrm>
            <a:off x="1812290" y="509270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Boy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4492625" y="509270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Girls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7130415" y="509270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Urban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9803130" y="5092700"/>
            <a:ext cx="12242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>
                <a:latin typeface="Times New Roman" panose="02020603050405020304" charset="0"/>
                <a:cs typeface="Times New Roman" panose="02020603050405020304" charset="0"/>
              </a:rPr>
              <a:t>Rural</a:t>
            </a:r>
            <a:endParaRPr lang="en-US" altLang="zh-CN" sz="9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717655" y="3237865"/>
            <a:ext cx="405765" cy="18034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2"/>
          <a:srcRect l="1374"/>
          <a:stretch>
            <a:fillRect/>
          </a:stretch>
        </p:blipFill>
        <p:spPr>
          <a:xfrm>
            <a:off x="1120140" y="2337435"/>
            <a:ext cx="2596515" cy="263906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/>
          <a:srcRect t="682"/>
          <a:stretch>
            <a:fillRect/>
          </a:stretch>
        </p:blipFill>
        <p:spPr>
          <a:xfrm>
            <a:off x="3740150" y="2369185"/>
            <a:ext cx="2663825" cy="260731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rcRect t="782"/>
          <a:stretch>
            <a:fillRect/>
          </a:stretch>
        </p:blipFill>
        <p:spPr>
          <a:xfrm>
            <a:off x="6436995" y="2374265"/>
            <a:ext cx="2643505" cy="259588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rcRect t="443"/>
          <a:stretch>
            <a:fillRect/>
          </a:stretch>
        </p:blipFill>
        <p:spPr>
          <a:xfrm>
            <a:off x="9123045" y="2369185"/>
            <a:ext cx="2595245" cy="260731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16</Words>
  <Application>WPS 演示</Application>
  <PresentationFormat>宽屏</PresentationFormat>
  <Paragraphs>222</Paragraphs>
  <Slides>4</Slides>
  <Notes>5</Notes>
  <HiddenSlides>1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Times New Roman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修彦彦</dc:creator>
  <cp:lastModifiedBy>奥利奥炸薯条</cp:lastModifiedBy>
  <cp:revision>254</cp:revision>
  <dcterms:created xsi:type="dcterms:W3CDTF">2023-08-09T12:44:00Z</dcterms:created>
  <dcterms:modified xsi:type="dcterms:W3CDTF">2025-06-27T01:26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9EDF86214044C4186F5045FFE60C5B7_13</vt:lpwstr>
  </property>
  <property fmtid="{D5CDD505-2E9C-101B-9397-08002B2CF9AE}" pid="3" name="KSOProductBuildVer">
    <vt:lpwstr>2052-12.1.0.21541</vt:lpwstr>
  </property>
</Properties>
</file>